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2FB43-19EF-4E1B-AFF4-F7E9D6C974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5268F-6EEF-468C-A553-B570BA678B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EF8A1-8C5D-4E41-9AD8-9093C2555E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AFF71-A030-446B-ABC8-A6D5633E18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409C1-308C-4687-AD1C-DDDDFE43BE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9CDF1-F7EF-4E5D-A7FF-572A21D956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8680B-49FC-4626-A509-6292CDFA50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18A1C-3B09-423A-A76D-7E6A2ED06A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E95E9-49DC-460D-8D0E-C9A9DF7BE1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39C7A-20B1-4A40-9EB9-C732F6DA13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02587-CC7F-4328-A74A-9D13D06B10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66536-2996-4FE6-B3A2-591E110BEB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A11FDE-283E-4F62-AE4A-ECF8879F9EE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39640" y="907920"/>
          <a:ext cx="7772400" cy="4943520"/>
        </p:xfrm>
        <a:graphic>
          <a:graphicData uri="http://schemas.openxmlformats.org/drawingml/2006/table">
            <a:tbl>
              <a:tblPr/>
              <a:tblGrid>
                <a:gridCol w="936720"/>
                <a:gridCol w="1511280"/>
                <a:gridCol w="836640"/>
                <a:gridCol w="303120"/>
                <a:gridCol w="417600"/>
                <a:gridCol w="433440"/>
                <a:gridCol w="511200"/>
                <a:gridCol w="412560"/>
                <a:gridCol w="244440"/>
                <a:gridCol w="268560"/>
                <a:gridCol w="452160"/>
                <a:gridCol w="435240"/>
                <a:gridCol w="509400"/>
                <a:gridCol w="500040"/>
              </a:tblGrid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ibration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id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x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D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 rowSpan="9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all poly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ul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6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4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8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8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5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3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micellul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a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7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5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8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yl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.4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1.9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4.9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7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.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.2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/A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3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7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gn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SL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IL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4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9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6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5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7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9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rowSpan="11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iomass saccharification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treatment(% total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nt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.3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7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3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9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xos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.5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7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9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.7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.9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8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9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1.6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7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atic hydrolysis(% total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nt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4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3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0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4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3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9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xos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5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.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7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.7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.3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.0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7.2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.7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8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5.0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2.3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9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3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released sugar (% dry matter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xos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.8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.1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2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8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.7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.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2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nt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7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8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2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.9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7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4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.1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.4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.4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3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.0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.7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6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ermentable hexoses (% total hexose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.8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.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.1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.5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.2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7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827"/>
          <p:cNvSpPr/>
          <p:nvPr/>
        </p:nvSpPr>
        <p:spPr>
          <a:xfrm>
            <a:off x="473040" y="5877000"/>
            <a:ext cx="8059680" cy="63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, sample number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n, minimum value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x, maximum value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, standard deviation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ra: arabinose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yl: xylose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X/A: xylose/arabinose.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L: acid soluble lignin;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IL: acid insoluble lignin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828"/>
          <p:cNvSpPr/>
          <p:nvPr/>
        </p:nvSpPr>
        <p:spPr>
          <a:xfrm>
            <a:off x="414360" y="591480"/>
            <a:ext cx="864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ble S2 Calibration and validation sets for wall polymers (% dry matter) and biomass saccharification in transgenetic rice straw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29T05:07:36Z</dcterms:created>
  <dc:creator>微软中国</dc:creator>
  <dc:description/>
  <dc:language>en-US</dc:language>
  <cp:lastModifiedBy>0011692</cp:lastModifiedBy>
  <dcterms:modified xsi:type="dcterms:W3CDTF">2017-11-28T10:31:09Z</dcterms:modified>
  <cp:revision>2</cp:revision>
  <dc:subject/>
  <dc:title>幻灯片 1</dc:title>
</cp:coreProperties>
</file>